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08E60B-061D-47E7-9C66-288697F2C9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DA924-1BF3-42C2-B419-8172D45035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07B9F-9549-41A0-B270-B230DB4C3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B1A0EF-3EBB-4600-A0BA-2374DA5B0E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6B08E-04B6-435F-A86F-B06967198E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2F15B-20EA-4FA2-8AAB-F5561033B6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731EA-6115-47A5-8B9F-1F245FAACE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FD49B-EEB8-445F-8E68-4A2D413C01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54BCD-2160-4468-9C09-5452919965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AA854-1A77-4D8A-B428-573E252440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8B0810-7C74-4FC9-BD65-F5183FD4DD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9153E-8034-4AF6-A63F-76EDFDFAAD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C9928D-4052-4C56-8166-F72C1E8974B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45200" y="560520"/>
            <a:ext cx="90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ELISA d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176480" y="1533600"/>
            <a:ext cx="133200" cy="8794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01920" y="1592280"/>
            <a:ext cx="129960" cy="8208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822320" y="1550880"/>
            <a:ext cx="135000" cy="8622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149560" y="1598760"/>
            <a:ext cx="128520" cy="8143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470320" y="1633680"/>
            <a:ext cx="133200" cy="7794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795760" y="1562040"/>
            <a:ext cx="128520" cy="8510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243080" y="1533600"/>
            <a:ext cx="1440" cy="39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231920" y="1573200"/>
            <a:ext cx="284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565280" y="1592280"/>
            <a:ext cx="0" cy="34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52680" y="1627200"/>
            <a:ext cx="284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889280" y="1550880"/>
            <a:ext cx="1440" cy="111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876320" y="1662120"/>
            <a:ext cx="30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11480" y="1598760"/>
            <a:ext cx="0" cy="63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198520" y="1662120"/>
            <a:ext cx="2880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36920" y="1633680"/>
            <a:ext cx="0" cy="1206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23960" y="1754280"/>
            <a:ext cx="2880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857680" y="1562040"/>
            <a:ext cx="1440" cy="111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844720" y="1673280"/>
            <a:ext cx="30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1243080" y="1487520"/>
            <a:ext cx="1440" cy="460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31920" y="1487520"/>
            <a:ext cx="284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1565280" y="1555560"/>
            <a:ext cx="0" cy="363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552680" y="1555920"/>
            <a:ext cx="284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1889280" y="1434960"/>
            <a:ext cx="1440" cy="115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876320" y="1434960"/>
            <a:ext cx="302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2211480" y="1538280"/>
            <a:ext cx="0" cy="604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198520" y="1538280"/>
            <a:ext cx="2880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V="1">
            <a:off x="2536920" y="1509840"/>
            <a:ext cx="0" cy="1238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23960" y="1509840"/>
            <a:ext cx="2880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2857680" y="1446120"/>
            <a:ext cx="1440" cy="115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844720" y="1446120"/>
            <a:ext cx="302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081080" y="1324080"/>
            <a:ext cx="0" cy="1089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063800" y="2413080"/>
            <a:ext cx="1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063800" y="2303640"/>
            <a:ext cx="1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063800" y="219852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063800" y="208764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063800" y="1976400"/>
            <a:ext cx="172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063800" y="1871640"/>
            <a:ext cx="1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063800" y="176220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63800" y="165096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063800" y="1538280"/>
            <a:ext cx="1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063800" y="1434960"/>
            <a:ext cx="172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063800" y="132408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081080" y="2413080"/>
            <a:ext cx="19400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1081080" y="241308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1406520" y="241308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1727280" y="241308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2052720" y="241308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2373480" y="241308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2700360" y="241308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021120" y="2413080"/>
            <a:ext cx="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680840" y="1054080"/>
            <a:ext cx="503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</a:rPr>
              <a:t>MMP-1 MCF-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911160" y="236700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911160" y="225576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0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911160" y="215100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911160" y="203976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1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911160" y="193032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2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911160" y="182556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2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911160" y="171468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3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911160" y="160344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3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911160" y="149220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4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911160" y="138744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45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911160" y="127800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175400" y="2478240"/>
            <a:ext cx="124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500120" y="2478240"/>
            <a:ext cx="119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805400" y="247824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hor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134080" y="2478240"/>
            <a:ext cx="188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on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442960" y="2478240"/>
            <a:ext cx="240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4-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802600" y="24782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rot="16200000">
            <a:off x="684000" y="1840680"/>
            <a:ext cx="340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</a:rPr>
              <a:t>Abs 405n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763560" y="996840"/>
            <a:ext cx="2293920" cy="165096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127400" y="1662120"/>
            <a:ext cx="133560" cy="7462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451400" y="1463760"/>
            <a:ext cx="129960" cy="9446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772160" y="1440000"/>
            <a:ext cx="133200" cy="9684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097600" y="1492200"/>
            <a:ext cx="133200" cy="9162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5421240" y="1457280"/>
            <a:ext cx="130320" cy="9511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5743440" y="1498680"/>
            <a:ext cx="131760" cy="9097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 flipV="1">
            <a:off x="4194000" y="1492200"/>
            <a:ext cx="0" cy="169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181400" y="1492200"/>
            <a:ext cx="28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flipV="1">
            <a:off x="4513320" y="1445760"/>
            <a:ext cx="1440" cy="176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502160" y="1446120"/>
            <a:ext cx="284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4838760" y="1387440"/>
            <a:ext cx="1440" cy="525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826160" y="1387440"/>
            <a:ext cx="2988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flipV="1">
            <a:off x="5164200" y="1456920"/>
            <a:ext cx="1440" cy="349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151600" y="1457280"/>
            <a:ext cx="2988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5484960" y="1434960"/>
            <a:ext cx="0" cy="223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472000" y="1434960"/>
            <a:ext cx="288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5810400" y="1446120"/>
            <a:ext cx="0" cy="5256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5797440" y="1446120"/>
            <a:ext cx="2880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194000" y="1662120"/>
            <a:ext cx="0" cy="163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181400" y="1825560"/>
            <a:ext cx="288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513320" y="1463760"/>
            <a:ext cx="144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502160" y="1481040"/>
            <a:ext cx="284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838760" y="1440000"/>
            <a:ext cx="1440" cy="586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826160" y="1498680"/>
            <a:ext cx="2988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5164200" y="1492200"/>
            <a:ext cx="1440" cy="28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5151600" y="1521000"/>
            <a:ext cx="2988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5484960" y="1457280"/>
            <a:ext cx="0" cy="302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472000" y="1487520"/>
            <a:ext cx="288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5810400" y="1498680"/>
            <a:ext cx="0" cy="522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5797440" y="1550880"/>
            <a:ext cx="2880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032360" y="1306440"/>
            <a:ext cx="0" cy="1101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014720" y="240840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014720" y="222876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014720" y="2039760"/>
            <a:ext cx="176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014720" y="185904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014720" y="1673280"/>
            <a:ext cx="176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014720" y="1492200"/>
            <a:ext cx="176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014720" y="1306440"/>
            <a:ext cx="176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032360" y="2408400"/>
            <a:ext cx="1939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4032360" y="24084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4356000" y="24084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4676760" y="240840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5000760" y="240840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5326200" y="2408400"/>
            <a:ext cx="144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5646600" y="24084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5972040" y="2408400"/>
            <a:ext cx="0" cy="23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759920" y="1042920"/>
            <a:ext cx="3754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MMP-1 Fi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3860640" y="236052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0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860640" y="218124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860640" y="199404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2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860640" y="181296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3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860640" y="162720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4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860640" y="144612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5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860640" y="1260360"/>
            <a:ext cx="159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0.6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127040" y="2471760"/>
            <a:ext cx="1454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4455720" y="2471760"/>
            <a:ext cx="140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4755240" y="2471760"/>
            <a:ext cx="192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hor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5086800" y="2471760"/>
            <a:ext cx="188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on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396400" y="2471760"/>
            <a:ext cx="218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4-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5756040" y="24717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rot="16200000">
            <a:off x="3641400" y="1824120"/>
            <a:ext cx="340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Arial"/>
              </a:rPr>
              <a:t>Abs 405n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714840" y="990720"/>
            <a:ext cx="2293920" cy="1650960"/>
          </a:xfrm>
          <a:prstGeom prst="rect">
            <a:avLst/>
          </a:pr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4" name=""/>
          <p:cNvGrpSpPr/>
          <p:nvPr/>
        </p:nvGrpSpPr>
        <p:grpSpPr>
          <a:xfrm>
            <a:off x="762120" y="2809800"/>
            <a:ext cx="2283840" cy="1709640"/>
            <a:chOff x="762120" y="2809800"/>
            <a:chExt cx="2283840" cy="1709640"/>
          </a:xfrm>
        </p:grpSpPr>
        <p:sp>
          <p:nvSpPr>
            <p:cNvPr id="175" name=""/>
            <p:cNvSpPr/>
            <p:nvPr/>
          </p:nvSpPr>
          <p:spPr>
            <a:xfrm>
              <a:off x="1184040" y="3560400"/>
              <a:ext cx="128160" cy="721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498320" y="3552480"/>
              <a:ext cx="134280" cy="729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820880" y="3595320"/>
              <a:ext cx="126360" cy="686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135160" y="3588840"/>
              <a:ext cx="134640" cy="693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457720" y="3681000"/>
              <a:ext cx="126360" cy="601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772000" y="3574800"/>
              <a:ext cx="136080" cy="7074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1243080" y="3466440"/>
              <a:ext cx="1800" cy="9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217520" y="346680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1565640" y="3366360"/>
              <a:ext cx="1440" cy="18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541880" y="336672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V="1">
              <a:off x="1879920" y="3381120"/>
              <a:ext cx="1440" cy="21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854720" y="338112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V="1">
              <a:off x="2204280" y="3438000"/>
              <a:ext cx="0" cy="150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176920" y="343836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flipV="1">
              <a:off x="2514960" y="3531600"/>
              <a:ext cx="1800" cy="148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491200" y="353196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2839320" y="3431880"/>
              <a:ext cx="1440" cy="14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813760" y="343188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243080" y="3560400"/>
              <a:ext cx="1800" cy="9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1217520" y="3654000"/>
              <a:ext cx="59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565640" y="3552480"/>
              <a:ext cx="1440" cy="193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1541880" y="374616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879920" y="3595320"/>
              <a:ext cx="1440" cy="20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1854720" y="380340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204280" y="3588840"/>
              <a:ext cx="0" cy="15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176920" y="3739680"/>
              <a:ext cx="59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514960" y="3681000"/>
              <a:ext cx="1800" cy="158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2491200" y="3839760"/>
              <a:ext cx="59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2839320" y="3574800"/>
              <a:ext cx="1440" cy="142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2813760" y="3717720"/>
              <a:ext cx="59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1090800" y="4282560"/>
              <a:ext cx="190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1405440" y="42822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flipV="1">
              <a:off x="1727640" y="428220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2040480" y="42822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 flipV="1">
              <a:off x="2364480" y="428220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2678760" y="4282200"/>
              <a:ext cx="180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V="1">
              <a:off x="3000960" y="4282200"/>
              <a:ext cx="180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1167120" y="4347720"/>
              <a:ext cx="140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1491480" y="4341600"/>
              <a:ext cx="119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786320" y="43416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2117160" y="4341600"/>
              <a:ext cx="14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2387880" y="4346280"/>
              <a:ext cx="19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2783160" y="4346280"/>
              <a:ext cx="8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1090800" y="3016080"/>
              <a:ext cx="1800" cy="1266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1063800" y="4282560"/>
              <a:ext cx="26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1063800" y="4033440"/>
              <a:ext cx="266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1063800" y="3774600"/>
              <a:ext cx="26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1063800" y="3524040"/>
              <a:ext cx="26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1063800" y="3266640"/>
              <a:ext cx="26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063800" y="3016080"/>
              <a:ext cx="2664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1090800" y="4282200"/>
              <a:ext cx="1800" cy="2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971280" y="4231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894600" y="3982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971280" y="3725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894600" y="3473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971280" y="3215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894600" y="2966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rot="16200000">
              <a:off x="577800" y="3618360"/>
              <a:ext cx="563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bs 450-620n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762120" y="2809800"/>
              <a:ext cx="2283840" cy="17096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4" name=""/>
          <p:cNvGrpSpPr/>
          <p:nvPr/>
        </p:nvGrpSpPr>
        <p:grpSpPr>
          <a:xfrm>
            <a:off x="3736800" y="2809800"/>
            <a:ext cx="2286000" cy="1709640"/>
            <a:chOff x="3736800" y="2809800"/>
            <a:chExt cx="2286000" cy="1709640"/>
          </a:xfrm>
        </p:grpSpPr>
        <p:sp>
          <p:nvSpPr>
            <p:cNvPr id="235" name=""/>
            <p:cNvSpPr/>
            <p:nvPr/>
          </p:nvSpPr>
          <p:spPr>
            <a:xfrm>
              <a:off x="4239000" y="3548160"/>
              <a:ext cx="130680" cy="729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551120" y="3591000"/>
              <a:ext cx="122400" cy="6868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855320" y="3461760"/>
              <a:ext cx="130680" cy="816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5167440" y="3569760"/>
              <a:ext cx="122400" cy="708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471280" y="3484080"/>
              <a:ext cx="131040" cy="7938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782320" y="3505680"/>
              <a:ext cx="123480" cy="772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4304880" y="3383280"/>
              <a:ext cx="1440" cy="164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280400" y="338364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4609080" y="3412440"/>
              <a:ext cx="1080" cy="17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584600" y="341280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4919760" y="3296520"/>
              <a:ext cx="1440" cy="164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4895280" y="329688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5223600" y="3390840"/>
              <a:ext cx="1080" cy="17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5199120" y="339120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V="1">
              <a:off x="5536080" y="3447360"/>
              <a:ext cx="108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5511600" y="344772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V="1">
              <a:off x="5839920" y="3362400"/>
              <a:ext cx="1440" cy="14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815440" y="336240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304880" y="3548160"/>
              <a:ext cx="1440" cy="164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280400" y="371304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609080" y="3591000"/>
              <a:ext cx="1080" cy="17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584600" y="377064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919760" y="3461760"/>
              <a:ext cx="1440" cy="171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895280" y="363384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223600" y="3569760"/>
              <a:ext cx="1080" cy="185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5199120" y="375552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536080" y="3484080"/>
              <a:ext cx="1080" cy="3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5511600" y="3519360"/>
              <a:ext cx="57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839920" y="3505680"/>
              <a:ext cx="1440" cy="143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5815440" y="3648960"/>
              <a:ext cx="57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4148280" y="4277880"/>
              <a:ext cx="108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4460760" y="4277880"/>
              <a:ext cx="108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flipV="1">
              <a:off x="4764240" y="4277880"/>
              <a:ext cx="108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 flipV="1">
              <a:off x="5076720" y="4277880"/>
              <a:ext cx="108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flipV="1">
              <a:off x="5380560" y="4277880"/>
              <a:ext cx="144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 flipV="1">
              <a:off x="5691600" y="4277880"/>
              <a:ext cx="108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V="1">
              <a:off x="5995080" y="4277880"/>
              <a:ext cx="144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189680" y="4340880"/>
              <a:ext cx="162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o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4492800" y="4340880"/>
              <a:ext cx="162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821120" y="43434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5099400" y="4340880"/>
              <a:ext cx="1666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5429520" y="4340880"/>
              <a:ext cx="218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4- 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5748840" y="4340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4149720" y="3010680"/>
              <a:ext cx="1440" cy="1267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123800" y="427824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4123800" y="402840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123800" y="377064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4123800" y="351936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4123800" y="326196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123800" y="301068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V="1">
              <a:off x="4149720" y="4277880"/>
              <a:ext cx="1440" cy="2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560" bIns="-25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4034520" y="4226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959280" y="39780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034520" y="3720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959280" y="3467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034520" y="3211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959280" y="2961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rot="16200000">
              <a:off x="3610080" y="3561120"/>
              <a:ext cx="563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Abs 450-620nm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143600" y="4279320"/>
              <a:ext cx="18442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3736800" y="2809800"/>
              <a:ext cx="2286000" cy="17096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5" name=""/>
          <p:cNvSpPr/>
          <p:nvPr/>
        </p:nvSpPr>
        <p:spPr>
          <a:xfrm>
            <a:off x="1606680" y="2863800"/>
            <a:ext cx="683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MP-2 MCF-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650480" y="2863800"/>
            <a:ext cx="555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600" spc="-1" strike="noStrike">
                <a:solidFill>
                  <a:srgbClr val="000000"/>
                </a:solidFill>
                <a:latin typeface="Arial"/>
              </a:rPr>
              <a:t>MMP-2 Fib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3T19:27:41Z</dcterms:created>
  <dc:creator>CRUK CRUK</dc:creator>
  <dc:description/>
  <dc:language>en-US</dc:language>
  <cp:lastModifiedBy>CRUK CRUK</cp:lastModifiedBy>
  <dcterms:modified xsi:type="dcterms:W3CDTF">2009-01-13T19:30:37Z</dcterms:modified>
  <cp:revision>4</cp:revision>
  <dc:subject/>
  <dc:title>PowerPoint Presentation</dc:title>
</cp:coreProperties>
</file>